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79200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5746D-2D6A-4E62-91D6-EA371973AF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822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577400"/>
            <a:ext cx="822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0693D-0D65-496E-80F6-695717F79F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84752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57740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57740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9FAEE-AF47-4D20-9F8A-0B5A2D6B67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264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847520"/>
            <a:ext cx="264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847520"/>
            <a:ext cx="264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577400"/>
            <a:ext cx="264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577400"/>
            <a:ext cx="264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577400"/>
            <a:ext cx="264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2927D-C8E8-4937-A38F-D8C274086D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847520"/>
            <a:ext cx="8229600" cy="522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A4B1E-03DC-4F30-9E00-3F43698FCD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8229600" cy="522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67607-6933-4655-A82F-23DB03A6B7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4015800" cy="522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847520"/>
            <a:ext cx="4015800" cy="522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7C990-CAAB-43B5-8C3C-C36FA7640E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C4F5F-88C8-4A41-A752-E954E9E73A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317520"/>
            <a:ext cx="8229600" cy="611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DABD3-E9CF-4D68-9DD6-9A35171086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847520"/>
            <a:ext cx="4015800" cy="522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57740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2AD7A-EAB8-4B90-95D3-36026F451B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4015800" cy="522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84752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57740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1F167-67DA-4161-9C3F-ECA4E8B34B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84752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847520"/>
            <a:ext cx="40158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577400"/>
            <a:ext cx="8229600" cy="249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36785-39FF-4F03-80AA-4495233775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317520"/>
            <a:ext cx="8229600" cy="131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847520"/>
            <a:ext cx="8229600" cy="522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7338600"/>
            <a:ext cx="2133720" cy="42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80195D-5509-4382-8172-C64043E8E877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7338600"/>
            <a:ext cx="2895840" cy="42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7338600"/>
            <a:ext cx="2133720" cy="42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DE733B-5E7C-49F4-AD69-679FD0CF5FC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693000" y="254160"/>
            <a:ext cx="566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2. Cell cycle mutants simulated by our model of DNA replication initia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8"/>
          <p:cNvSpPr/>
          <p:nvPr/>
        </p:nvSpPr>
        <p:spPr>
          <a:xfrm>
            <a:off x="545040" y="3578400"/>
            <a:ext cx="638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3. Cell cycle mutants reported in Chen et al. [45], simulated by the combined model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066680" y="3959280"/>
          <a:ext cx="6553440" cy="1620720"/>
        </p:xfrm>
        <a:graphic>
          <a:graphicData uri="http://schemas.openxmlformats.org/drawingml/2006/table">
            <a:tbl>
              <a:tblPr/>
              <a:tblGrid>
                <a:gridCol w="2178000"/>
                <a:gridCol w="2108520"/>
                <a:gridCol w="2266920"/>
              </a:tblGrid>
              <a:tr h="260280">
                <a:tc>
                  <a:txBody>
                    <a:bodyPr lIns="8280" rIns="8280" tIns="97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uta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97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en et al. Simulated Phenotyp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97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mbined Model Simulated Phenotyp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92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n1Δcln2Δcln3Δ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 arr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n1Δcln2Δcln3Δsic1Δ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ab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n1Δcln2Δcln3Δcdh1Δ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lophase arr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c20Δpds1Δ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lophase arr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172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c20Δclb5Δ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phase arr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c20Δpds1Δclb5Δ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ab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c1Δcdh1Δcdc6Δ2-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lophase arrest-like phenotyp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c1Δcdh1Δcdc6Δ2-49 GALL-CDC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ab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97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cal profi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Box 6"/>
          <p:cNvSpPr/>
          <p:nvPr/>
        </p:nvSpPr>
        <p:spPr>
          <a:xfrm>
            <a:off x="533520" y="2994120"/>
            <a:ext cx="8076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* This is an estimate of the defect of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dc45-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in initiating replication. It is likely that the phenotype is more severe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n vivo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** This is simulated using Cdc45 as a proxy for the complex that stabilizes CMG at origins. A three-fold increase in levels and association (overexpression) was simulated by the model based on Western blotting results from [3].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838080" y="530280"/>
          <a:ext cx="7239240" cy="2362320"/>
        </p:xfrm>
        <a:graphic>
          <a:graphicData uri="http://schemas.openxmlformats.org/drawingml/2006/table">
            <a:tbl>
              <a:tblPr/>
              <a:tblGrid>
                <a:gridCol w="1447920"/>
                <a:gridCol w="1523880"/>
                <a:gridCol w="1849680"/>
                <a:gridCol w="817560"/>
                <a:gridCol w="1600200"/>
              </a:tblGrid>
              <a:tr h="22860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nt/Perturba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bservations from Model Simula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perimental Pheno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igins fired/cell cycle                  (% WT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ferenc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ild-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–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-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is stud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80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6 knockdown (to 10%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3% peak [FORK] height reduc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 arrest within 2 h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is stud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bf4 knockdown (to 10%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8% peak [FORK] height reduc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 arrest within 2 h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.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is stud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80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t1 knockdown (to 10%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% peak [FORK] height reductio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 arrest within 8 h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4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is stud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bf4-Mcm2 interaction halv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% longer S phas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lower S-phase, reduced initiation at origins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.5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ones et al. [73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45-1 </a:t>
                      </a: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pre-RC association halved*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% longer S phas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lower S-phase, reduced initiation at origins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.5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ou et al. [74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6Δ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 replication fork fi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abl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ccharomyces Genome Deletion Proj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bf4Δ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 replication fork fi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abl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ccharomyces Genome Deletion Proj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t1Δ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 replication fork fi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abl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ccharomyces Genome Deletion Proj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m2Δ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 replication fork fi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abl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ccharomyces Genome Deletion Proj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45Δ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 replication fork fi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abl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ccharomyces Genome Deletion Proj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45/Sld3/Sld7 overexpression**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crease in origins fir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crease in fired origins to 134% of wildtyp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9%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naka et al. [55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t1 M-G1 deplet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m2-7 excluded from nucleu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m2-7 excluded from nucleu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naka et al. [7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3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m2-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14 reduced to zero: S phase 49% longe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layed passage through S phase/initiation def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7.2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Yan et al. [94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m3-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14 reduced to zero: no FORK produce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able at restrictive temperatur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Yan et al. [95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80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c2-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24 reduced by 20%: reduced origin fi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C-DNA binding defect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1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ibson et al. [60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6-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rest in RC2 state (G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 arrest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tweiler and Li [96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c7-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rest in RC5 state (G1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 arrest (failure to enter S-phase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ousset and Diffley [97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4T20:58:51Z</dcterms:created>
  <dc:creator>Rohan Gidvani</dc:creator>
  <dc:description/>
  <dc:language>en-US</dc:language>
  <cp:lastModifiedBy>Rohan Gidvani</cp:lastModifiedBy>
  <cp:lastPrinted>2012-04-22T15:56:58Z</cp:lastPrinted>
  <dcterms:modified xsi:type="dcterms:W3CDTF">2012-06-17T22:51:09Z</dcterms:modified>
  <cp:revision>12</cp:revision>
  <dc:subject/>
  <dc:title>Slide 1</dc:title>
</cp:coreProperties>
</file>